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490" autoAdjust="0"/>
    <p:restoredTop sz="85627" autoAdjust="0"/>
  </p:normalViewPr>
  <p:slideViewPr>
    <p:cSldViewPr snapToGrid="0" snapToObjects="1">
      <p:cViewPr varScale="1">
        <p:scale>
          <a:sx n="78" d="100"/>
          <a:sy n="78" d="100"/>
        </p:scale>
        <p:origin x="-942" y="-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CBE3766-E641-AB46-BB52-3850097C33DA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8F8F50-7C1F-1445-A60C-715B0E07848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41707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C5C442-2F04-D247-AFC1-2689154C4B54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B43055-29F0-6B41-9D6F-0A67EC9F796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61917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 smtClean="0"/>
              <a:t>Pathway networks for the three distinct treatments. A) IF vs NO; B)IFCQ vs NO; C)IFCQ vs N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DB43055-29F0-6B41-9D6F-0A67EC9F796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308190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3397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901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210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41305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1960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644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92704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85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718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1552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6729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D4AE64-D5F9-8A4D-956B-FE07949EF371}" type="datetimeFigureOut">
              <a:rPr lang="en-US" smtClean="0"/>
              <a:t>11/30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99A8B5-3830-6144-85E0-D8FFA5F3C9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6253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0876262" y="6304758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/>
              <a:t>Figure </a:t>
            </a:r>
            <a:r>
              <a:rPr lang="en-US" b="1" dirty="0" smtClean="0"/>
              <a:t>S3</a:t>
            </a:r>
            <a:endParaRPr lang="en-US" b="1" dirty="0"/>
          </a:p>
        </p:txBody>
      </p:sp>
      <p:grpSp>
        <p:nvGrpSpPr>
          <p:cNvPr id="3" name="Group 2"/>
          <p:cNvGrpSpPr/>
          <p:nvPr/>
        </p:nvGrpSpPr>
        <p:grpSpPr>
          <a:xfrm>
            <a:off x="331183" y="148588"/>
            <a:ext cx="3941998" cy="3091798"/>
            <a:chOff x="452090" y="320040"/>
            <a:chExt cx="3941998" cy="3091798"/>
          </a:xfrm>
        </p:grpSpPr>
        <p:grpSp>
          <p:nvGrpSpPr>
            <p:cNvPr id="4" name="Group 3"/>
            <p:cNvGrpSpPr/>
            <p:nvPr/>
          </p:nvGrpSpPr>
          <p:grpSpPr>
            <a:xfrm>
              <a:off x="922397" y="799357"/>
              <a:ext cx="1210550" cy="523220"/>
              <a:chOff x="9361481" y="4621063"/>
              <a:chExt cx="1541251" cy="535283"/>
            </a:xfrm>
          </p:grpSpPr>
          <p:sp>
            <p:nvSpPr>
              <p:cNvPr id="36" name="Rounded Rectangle 35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9410874" y="4621063"/>
                <a:ext cx="1491858" cy="5352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Antigen Presentation</a:t>
                </a:r>
                <a:endParaRPr lang="en-US" sz="1400" b="1" dirty="0"/>
              </a:p>
            </p:txBody>
          </p:sp>
        </p:grpSp>
        <p:cxnSp>
          <p:nvCxnSpPr>
            <p:cNvPr id="5" name="Straight Connector 4"/>
            <p:cNvCxnSpPr>
              <a:stCxn id="36" idx="2"/>
              <a:endCxn id="30" idx="0"/>
            </p:cNvCxnSpPr>
            <p:nvPr/>
          </p:nvCxnSpPr>
          <p:spPr>
            <a:xfrm flipH="1">
              <a:off x="1292704" y="1293527"/>
              <a:ext cx="191386" cy="1595091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" name="Group 5"/>
            <p:cNvGrpSpPr/>
            <p:nvPr/>
          </p:nvGrpSpPr>
          <p:grpSpPr>
            <a:xfrm>
              <a:off x="3494803" y="883147"/>
              <a:ext cx="561567" cy="329130"/>
              <a:chOff x="9361481" y="4621063"/>
              <a:chExt cx="1541251" cy="505563"/>
            </a:xfrm>
          </p:grpSpPr>
          <p:sp>
            <p:nvSpPr>
              <p:cNvPr id="34" name="Rounded Rectangle 33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9410874" y="4621063"/>
                <a:ext cx="1491858" cy="3148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Th2</a:t>
                </a:r>
                <a:endParaRPr lang="en-US" sz="1400" b="1" dirty="0"/>
              </a:p>
            </p:txBody>
          </p:sp>
        </p:grpSp>
        <p:grpSp>
          <p:nvGrpSpPr>
            <p:cNvPr id="7" name="Group 6"/>
            <p:cNvGrpSpPr/>
            <p:nvPr/>
          </p:nvGrpSpPr>
          <p:grpSpPr>
            <a:xfrm>
              <a:off x="2580476" y="2295186"/>
              <a:ext cx="561567" cy="329130"/>
              <a:chOff x="9361481" y="4621063"/>
              <a:chExt cx="1541251" cy="505563"/>
            </a:xfrm>
          </p:grpSpPr>
          <p:sp>
            <p:nvSpPr>
              <p:cNvPr id="32" name="Rounded Rectangle 31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33" name="Rectangle 32"/>
              <p:cNvSpPr/>
              <p:nvPr/>
            </p:nvSpPr>
            <p:spPr>
              <a:xfrm>
                <a:off x="9410875" y="4621063"/>
                <a:ext cx="1491857" cy="47276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Th1</a:t>
                </a:r>
                <a:endParaRPr lang="en-US" sz="1400" b="1" dirty="0"/>
              </a:p>
            </p:txBody>
          </p:sp>
        </p:grpSp>
        <p:grpSp>
          <p:nvGrpSpPr>
            <p:cNvPr id="8" name="Group 7"/>
            <p:cNvGrpSpPr/>
            <p:nvPr/>
          </p:nvGrpSpPr>
          <p:grpSpPr>
            <a:xfrm>
              <a:off x="731011" y="2888618"/>
              <a:ext cx="1210550" cy="523220"/>
              <a:chOff x="9361481" y="4621063"/>
              <a:chExt cx="1541251" cy="535283"/>
            </a:xfrm>
          </p:grpSpPr>
          <p:sp>
            <p:nvSpPr>
              <p:cNvPr id="30" name="Rounded Rectangle 29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31" name="Rectangle 30"/>
              <p:cNvSpPr/>
              <p:nvPr/>
            </p:nvSpPr>
            <p:spPr>
              <a:xfrm>
                <a:off x="9410874" y="4621063"/>
                <a:ext cx="1491858" cy="5352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Th1 and Th2 activation</a:t>
                </a:r>
                <a:endParaRPr lang="en-US" sz="1400" b="1" dirty="0"/>
              </a:p>
            </p:txBody>
          </p:sp>
        </p:grpSp>
        <p:grpSp>
          <p:nvGrpSpPr>
            <p:cNvPr id="9" name="Group 8"/>
            <p:cNvGrpSpPr/>
            <p:nvPr/>
          </p:nvGrpSpPr>
          <p:grpSpPr>
            <a:xfrm>
              <a:off x="3116650" y="3013573"/>
              <a:ext cx="1277438" cy="398265"/>
              <a:chOff x="9361481" y="4621063"/>
              <a:chExt cx="1491858" cy="561089"/>
            </a:xfrm>
          </p:grpSpPr>
          <p:sp>
            <p:nvSpPr>
              <p:cNvPr id="28" name="Rounded Rectangle 27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29" name="Rectangle 28"/>
              <p:cNvSpPr/>
              <p:nvPr/>
            </p:nvSpPr>
            <p:spPr>
              <a:xfrm>
                <a:off x="9361481" y="4646869"/>
                <a:ext cx="1491858" cy="5352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Osteoarthritis</a:t>
                </a:r>
                <a:endParaRPr lang="en-US" sz="1400" b="1" dirty="0"/>
              </a:p>
            </p:txBody>
          </p:sp>
        </p:grpSp>
        <p:cxnSp>
          <p:nvCxnSpPr>
            <p:cNvPr id="10" name="Straight Connector 9"/>
            <p:cNvCxnSpPr>
              <a:stCxn id="34" idx="2"/>
              <a:endCxn id="30" idx="0"/>
            </p:cNvCxnSpPr>
            <p:nvPr/>
          </p:nvCxnSpPr>
          <p:spPr>
            <a:xfrm flipH="1">
              <a:off x="1292704" y="1212277"/>
              <a:ext cx="2462665" cy="1676341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>
              <a:stCxn id="28" idx="1"/>
              <a:endCxn id="30" idx="3"/>
            </p:cNvCxnSpPr>
            <p:nvPr/>
          </p:nvCxnSpPr>
          <p:spPr>
            <a:xfrm flipH="1" flipV="1">
              <a:off x="1854396" y="3135703"/>
              <a:ext cx="1262254" cy="5729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>
              <a:stCxn id="34" idx="2"/>
              <a:endCxn id="28" idx="0"/>
            </p:cNvCxnSpPr>
            <p:nvPr/>
          </p:nvCxnSpPr>
          <p:spPr>
            <a:xfrm flipH="1">
              <a:off x="3729003" y="1212277"/>
              <a:ext cx="26366" cy="1801296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Straight Connector 12"/>
            <p:cNvCxnSpPr>
              <a:stCxn id="36" idx="3"/>
              <a:endCxn id="34" idx="1"/>
            </p:cNvCxnSpPr>
            <p:nvPr/>
          </p:nvCxnSpPr>
          <p:spPr>
            <a:xfrm>
              <a:off x="2045782" y="1046442"/>
              <a:ext cx="1449021" cy="127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Straight Connector 13"/>
            <p:cNvCxnSpPr>
              <a:stCxn id="36" idx="2"/>
              <a:endCxn id="32" idx="0"/>
            </p:cNvCxnSpPr>
            <p:nvPr/>
          </p:nvCxnSpPr>
          <p:spPr>
            <a:xfrm>
              <a:off x="1484090" y="1293527"/>
              <a:ext cx="1356952" cy="1001659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/>
            <p:cNvCxnSpPr>
              <a:stCxn id="30" idx="0"/>
              <a:endCxn id="32" idx="1"/>
            </p:cNvCxnSpPr>
            <p:nvPr/>
          </p:nvCxnSpPr>
          <p:spPr>
            <a:xfrm flipV="1">
              <a:off x="1292704" y="2459751"/>
              <a:ext cx="1287772" cy="428867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>
              <a:stCxn id="32" idx="3"/>
              <a:endCxn id="28" idx="0"/>
            </p:cNvCxnSpPr>
            <p:nvPr/>
          </p:nvCxnSpPr>
          <p:spPr>
            <a:xfrm>
              <a:off x="3101608" y="2459751"/>
              <a:ext cx="627395" cy="553822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Connector 16"/>
            <p:cNvCxnSpPr>
              <a:stCxn id="33" idx="0"/>
              <a:endCxn id="34" idx="2"/>
            </p:cNvCxnSpPr>
            <p:nvPr/>
          </p:nvCxnSpPr>
          <p:spPr>
            <a:xfrm flipV="1">
              <a:off x="2870258" y="1212277"/>
              <a:ext cx="885111" cy="1082909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1131881" y="197325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smtClean="0"/>
                <a:t>15</a:t>
              </a:r>
              <a:endParaRPr lang="en-US" sz="1200" b="1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11014" y="162983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5</a:t>
              </a:r>
              <a:endParaRPr lang="en-US" sz="12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619980" y="82481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5</a:t>
              </a:r>
              <a:endParaRPr lang="en-US" sz="12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377299" y="2964840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4</a:t>
              </a:r>
              <a:endParaRPr lang="en-US" sz="12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673484" y="201818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4</a:t>
              </a:r>
              <a:endParaRPr lang="en-US" sz="12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333887" y="253197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3</a:t>
              </a:r>
              <a:endParaRPr lang="en-US" sz="12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906312" y="240100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48</a:t>
              </a:r>
              <a:endParaRPr lang="en-US" sz="12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996185" y="165585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39</a:t>
              </a:r>
              <a:endParaRPr lang="en-US" sz="12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447094" y="174688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51</a:t>
              </a:r>
              <a:endParaRPr lang="en-US" sz="12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52090" y="320040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A</a:t>
              </a:r>
              <a:endParaRPr lang="en-US" b="1" dirty="0"/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7144714" y="134026"/>
            <a:ext cx="4680343" cy="3436813"/>
            <a:chOff x="6428320" y="280627"/>
            <a:chExt cx="4680343" cy="3436813"/>
          </a:xfrm>
        </p:grpSpPr>
        <p:grpSp>
          <p:nvGrpSpPr>
            <p:cNvPr id="39" name="Group 38"/>
            <p:cNvGrpSpPr/>
            <p:nvPr/>
          </p:nvGrpSpPr>
          <p:grpSpPr>
            <a:xfrm>
              <a:off x="6949817" y="759944"/>
              <a:ext cx="1210550" cy="523220"/>
              <a:chOff x="9361481" y="4621063"/>
              <a:chExt cx="1541251" cy="535283"/>
            </a:xfrm>
          </p:grpSpPr>
          <p:sp>
            <p:nvSpPr>
              <p:cNvPr id="71" name="Rounded Rectangle 70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9410874" y="4621063"/>
                <a:ext cx="1491858" cy="5352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Antigen Presentation</a:t>
                </a:r>
                <a:endParaRPr lang="en-US" sz="1400" b="1" dirty="0"/>
              </a:p>
            </p:txBody>
          </p:sp>
        </p:grpSp>
        <p:cxnSp>
          <p:nvCxnSpPr>
            <p:cNvPr id="40" name="Straight Connector 39"/>
            <p:cNvCxnSpPr>
              <a:stCxn id="71" idx="2"/>
              <a:endCxn id="67" idx="0"/>
            </p:cNvCxnSpPr>
            <p:nvPr/>
          </p:nvCxnSpPr>
          <p:spPr>
            <a:xfrm>
              <a:off x="7511510" y="1254114"/>
              <a:ext cx="1212831" cy="105566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1" name="Group 40"/>
            <p:cNvGrpSpPr/>
            <p:nvPr/>
          </p:nvGrpSpPr>
          <p:grpSpPr>
            <a:xfrm>
              <a:off x="9522223" y="843734"/>
              <a:ext cx="561567" cy="329130"/>
              <a:chOff x="9361481" y="4621063"/>
              <a:chExt cx="1541251" cy="505563"/>
            </a:xfrm>
          </p:grpSpPr>
          <p:sp>
            <p:nvSpPr>
              <p:cNvPr id="69" name="Rounded Rectangle 68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70" name="Rectangle 69"/>
              <p:cNvSpPr/>
              <p:nvPr/>
            </p:nvSpPr>
            <p:spPr>
              <a:xfrm>
                <a:off x="9410874" y="4621063"/>
                <a:ext cx="1491858" cy="3148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Th2</a:t>
                </a:r>
                <a:endParaRPr lang="en-US" sz="1400" b="1" dirty="0"/>
              </a:p>
            </p:txBody>
          </p:sp>
        </p:grpSp>
        <p:grpSp>
          <p:nvGrpSpPr>
            <p:cNvPr id="42" name="Group 41"/>
            <p:cNvGrpSpPr/>
            <p:nvPr/>
          </p:nvGrpSpPr>
          <p:grpSpPr>
            <a:xfrm>
              <a:off x="8162648" y="2309777"/>
              <a:ext cx="1210550" cy="523220"/>
              <a:chOff x="9361481" y="4621063"/>
              <a:chExt cx="1541251" cy="535283"/>
            </a:xfrm>
          </p:grpSpPr>
          <p:sp>
            <p:nvSpPr>
              <p:cNvPr id="67" name="Rounded Rectangle 66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9410874" y="4621063"/>
                <a:ext cx="1491858" cy="5352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Th1 and Th2 activation</a:t>
                </a:r>
                <a:endParaRPr lang="en-US" sz="1400" b="1" dirty="0"/>
              </a:p>
            </p:txBody>
          </p:sp>
        </p:grpSp>
        <p:grpSp>
          <p:nvGrpSpPr>
            <p:cNvPr id="43" name="Group 42"/>
            <p:cNvGrpSpPr/>
            <p:nvPr/>
          </p:nvGrpSpPr>
          <p:grpSpPr>
            <a:xfrm>
              <a:off x="9492914" y="2745016"/>
              <a:ext cx="1615749" cy="972424"/>
              <a:chOff x="8966384" y="4621063"/>
              <a:chExt cx="1886955" cy="1369985"/>
            </a:xfrm>
          </p:grpSpPr>
          <p:sp>
            <p:nvSpPr>
              <p:cNvPr id="65" name="Rounded Rectangle 64"/>
              <p:cNvSpPr/>
              <p:nvPr/>
            </p:nvSpPr>
            <p:spPr>
              <a:xfrm>
                <a:off x="8966384" y="4621063"/>
                <a:ext cx="1616060" cy="1359484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8966384" y="4646869"/>
                <a:ext cx="1886955" cy="134417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Hepatic Fibrosis/Hepatic Stellate Cell Activation</a:t>
                </a:r>
                <a:endParaRPr lang="en-US" sz="1400" b="1" dirty="0"/>
              </a:p>
            </p:txBody>
          </p:sp>
        </p:grpSp>
        <p:cxnSp>
          <p:nvCxnSpPr>
            <p:cNvPr id="44" name="Straight Connector 43"/>
            <p:cNvCxnSpPr>
              <a:stCxn id="69" idx="2"/>
              <a:endCxn id="67" idx="0"/>
            </p:cNvCxnSpPr>
            <p:nvPr/>
          </p:nvCxnSpPr>
          <p:spPr>
            <a:xfrm flipH="1">
              <a:off x="8724341" y="1172864"/>
              <a:ext cx="1058448" cy="113691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>
              <a:stCxn id="63" idx="3"/>
              <a:endCxn id="66" idx="1"/>
            </p:cNvCxnSpPr>
            <p:nvPr/>
          </p:nvCxnSpPr>
          <p:spPr>
            <a:xfrm>
              <a:off x="7602808" y="3031890"/>
              <a:ext cx="1890106" cy="208497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Straight Connector 45"/>
            <p:cNvCxnSpPr>
              <a:stCxn id="69" idx="2"/>
              <a:endCxn id="65" idx="0"/>
            </p:cNvCxnSpPr>
            <p:nvPr/>
          </p:nvCxnSpPr>
          <p:spPr>
            <a:xfrm>
              <a:off x="9782789" y="1172864"/>
              <a:ext cx="402020" cy="1572152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Straight Connector 46"/>
            <p:cNvCxnSpPr>
              <a:stCxn id="71" idx="3"/>
              <a:endCxn id="69" idx="1"/>
            </p:cNvCxnSpPr>
            <p:nvPr/>
          </p:nvCxnSpPr>
          <p:spPr>
            <a:xfrm>
              <a:off x="8073202" y="1007029"/>
              <a:ext cx="1449021" cy="127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>
              <a:stCxn id="71" idx="2"/>
              <a:endCxn id="64" idx="0"/>
            </p:cNvCxnSpPr>
            <p:nvPr/>
          </p:nvCxnSpPr>
          <p:spPr>
            <a:xfrm flipH="1">
              <a:off x="7040849" y="1254114"/>
              <a:ext cx="470661" cy="152532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Straight Connector 48"/>
            <p:cNvCxnSpPr>
              <a:stCxn id="67" idx="3"/>
              <a:endCxn id="65" idx="0"/>
            </p:cNvCxnSpPr>
            <p:nvPr/>
          </p:nvCxnSpPr>
          <p:spPr>
            <a:xfrm>
              <a:off x="9286033" y="2556862"/>
              <a:ext cx="898776" cy="18815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Straight Connector 49"/>
            <p:cNvCxnSpPr>
              <a:stCxn id="64" idx="0"/>
              <a:endCxn id="69" idx="2"/>
            </p:cNvCxnSpPr>
            <p:nvPr/>
          </p:nvCxnSpPr>
          <p:spPr>
            <a:xfrm flipV="1">
              <a:off x="7040849" y="1172864"/>
              <a:ext cx="2741940" cy="160657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TextBox 50"/>
            <p:cNvSpPr txBox="1"/>
            <p:nvPr/>
          </p:nvSpPr>
          <p:spPr>
            <a:xfrm>
              <a:off x="6970803" y="187171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3</a:t>
              </a:r>
              <a:endParaRPr lang="en-US" sz="1200" b="1" dirty="0"/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8053620" y="161028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5</a:t>
              </a:r>
              <a:endParaRPr lang="en-US" sz="1200" b="1" dirty="0"/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8647400" y="785398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5</a:t>
              </a:r>
              <a:endParaRPr lang="en-US" sz="1200" b="1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8404719" y="2925427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23</a:t>
              </a:r>
              <a:endParaRPr lang="en-US" sz="1200" b="1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9956612" y="1893442"/>
              <a:ext cx="2436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8</a:t>
              </a:r>
              <a:endParaRPr lang="en-US" sz="1200" b="1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9466088" y="241836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2</a:t>
              </a:r>
              <a:endParaRPr lang="en-US" sz="1200" b="1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7752913" y="273666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26</a:t>
              </a:r>
              <a:endParaRPr lang="en-US" sz="1200" b="1" dirty="0"/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9139866" y="1710631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65</a:t>
              </a:r>
              <a:endParaRPr lang="en-US" sz="1200" b="1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8376981" y="163619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23</a:t>
              </a:r>
              <a:endParaRPr lang="en-US" sz="1200" b="1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6479510" y="280627"/>
              <a:ext cx="32412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/>
                <a:t>B</a:t>
              </a:r>
              <a:endParaRPr lang="en-US" b="1" dirty="0"/>
            </a:p>
          </p:txBody>
        </p:sp>
        <p:grpSp>
          <p:nvGrpSpPr>
            <p:cNvPr id="61" name="Group 60"/>
            <p:cNvGrpSpPr/>
            <p:nvPr/>
          </p:nvGrpSpPr>
          <p:grpSpPr>
            <a:xfrm>
              <a:off x="6428320" y="2761121"/>
              <a:ext cx="1225058" cy="541538"/>
              <a:chOff x="9361481" y="4621062"/>
              <a:chExt cx="1491858" cy="762937"/>
            </a:xfrm>
          </p:grpSpPr>
          <p:sp>
            <p:nvSpPr>
              <p:cNvPr id="63" name="Rounded Rectangle 62"/>
              <p:cNvSpPr/>
              <p:nvPr/>
            </p:nvSpPr>
            <p:spPr>
              <a:xfrm>
                <a:off x="9361481" y="4621062"/>
                <a:ext cx="1430274" cy="762936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9361481" y="4646869"/>
                <a:ext cx="1491858" cy="73713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Dendritic cell maturation</a:t>
                </a:r>
                <a:endParaRPr lang="en-US" sz="1400" b="1" dirty="0"/>
              </a:p>
            </p:txBody>
          </p:sp>
        </p:grpSp>
        <p:cxnSp>
          <p:nvCxnSpPr>
            <p:cNvPr id="62" name="Straight Connector 61"/>
            <p:cNvCxnSpPr>
              <a:stCxn id="63" idx="3"/>
              <a:endCxn id="67" idx="2"/>
            </p:cNvCxnSpPr>
            <p:nvPr/>
          </p:nvCxnSpPr>
          <p:spPr>
            <a:xfrm flipV="1">
              <a:off x="7602808" y="2803947"/>
              <a:ext cx="1121533" cy="22794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3" name="Group 72"/>
          <p:cNvGrpSpPr/>
          <p:nvPr/>
        </p:nvGrpSpPr>
        <p:grpSpPr>
          <a:xfrm>
            <a:off x="4196418" y="3290324"/>
            <a:ext cx="4924695" cy="3436813"/>
            <a:chOff x="6580720" y="433027"/>
            <a:chExt cx="4924695" cy="3436813"/>
          </a:xfrm>
        </p:grpSpPr>
        <p:grpSp>
          <p:nvGrpSpPr>
            <p:cNvPr id="74" name="Group 73"/>
            <p:cNvGrpSpPr/>
            <p:nvPr/>
          </p:nvGrpSpPr>
          <p:grpSpPr>
            <a:xfrm>
              <a:off x="7102217" y="912344"/>
              <a:ext cx="1210550" cy="523220"/>
              <a:chOff x="9361481" y="4621063"/>
              <a:chExt cx="1541251" cy="535283"/>
            </a:xfrm>
          </p:grpSpPr>
          <p:sp>
            <p:nvSpPr>
              <p:cNvPr id="106" name="Rounded Rectangle 105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07" name="Rectangle 106"/>
              <p:cNvSpPr/>
              <p:nvPr/>
            </p:nvSpPr>
            <p:spPr>
              <a:xfrm>
                <a:off x="9410874" y="4621063"/>
                <a:ext cx="1491858" cy="5352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Antigen Presentation</a:t>
                </a:r>
                <a:endParaRPr lang="en-US" sz="1400" b="1" dirty="0"/>
              </a:p>
            </p:txBody>
          </p:sp>
        </p:grpSp>
        <p:cxnSp>
          <p:nvCxnSpPr>
            <p:cNvPr id="75" name="Straight Connector 74"/>
            <p:cNvCxnSpPr>
              <a:stCxn id="106" idx="2"/>
              <a:endCxn id="102" idx="0"/>
            </p:cNvCxnSpPr>
            <p:nvPr/>
          </p:nvCxnSpPr>
          <p:spPr>
            <a:xfrm>
              <a:off x="7663910" y="1406514"/>
              <a:ext cx="1212831" cy="105566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6" name="Group 75"/>
            <p:cNvGrpSpPr/>
            <p:nvPr/>
          </p:nvGrpSpPr>
          <p:grpSpPr>
            <a:xfrm>
              <a:off x="9674623" y="996130"/>
              <a:ext cx="1830792" cy="523221"/>
              <a:chOff x="9361481" y="4621061"/>
              <a:chExt cx="5024707" cy="803699"/>
            </a:xfrm>
          </p:grpSpPr>
          <p:sp>
            <p:nvSpPr>
              <p:cNvPr id="104" name="Rounded Rectangle 103"/>
              <p:cNvSpPr/>
              <p:nvPr/>
            </p:nvSpPr>
            <p:spPr>
              <a:xfrm>
                <a:off x="9361481" y="4621061"/>
                <a:ext cx="5024707" cy="799729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05" name="Rectangle 104"/>
              <p:cNvSpPr/>
              <p:nvPr/>
            </p:nvSpPr>
            <p:spPr>
              <a:xfrm>
                <a:off x="9410872" y="4621063"/>
                <a:ext cx="4899185" cy="803697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err="1" smtClean="0"/>
                  <a:t>Neuroinflammmation</a:t>
                </a:r>
                <a:r>
                  <a:rPr lang="en-US" sz="1400" b="1" dirty="0" smtClean="0"/>
                  <a:t> Signaling</a:t>
                </a:r>
                <a:endParaRPr lang="en-US" sz="1400" b="1" dirty="0"/>
              </a:p>
            </p:txBody>
          </p:sp>
        </p:grpSp>
        <p:grpSp>
          <p:nvGrpSpPr>
            <p:cNvPr id="77" name="Group 76"/>
            <p:cNvGrpSpPr/>
            <p:nvPr/>
          </p:nvGrpSpPr>
          <p:grpSpPr>
            <a:xfrm>
              <a:off x="8315048" y="2462177"/>
              <a:ext cx="1210550" cy="523220"/>
              <a:chOff x="9361481" y="4621063"/>
              <a:chExt cx="1541251" cy="535283"/>
            </a:xfrm>
          </p:grpSpPr>
          <p:sp>
            <p:nvSpPr>
              <p:cNvPr id="102" name="Rounded Rectangle 101"/>
              <p:cNvSpPr/>
              <p:nvPr/>
            </p:nvSpPr>
            <p:spPr>
              <a:xfrm>
                <a:off x="9361481" y="4621063"/>
                <a:ext cx="1430274" cy="505563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03" name="Rectangle 102"/>
              <p:cNvSpPr/>
              <p:nvPr/>
            </p:nvSpPr>
            <p:spPr>
              <a:xfrm>
                <a:off x="9410874" y="4621063"/>
                <a:ext cx="1491858" cy="5352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Th1 and Th2 activation</a:t>
                </a:r>
                <a:endParaRPr lang="en-US" sz="1400" b="1" dirty="0"/>
              </a:p>
            </p:txBody>
          </p:sp>
        </p:grpSp>
        <p:grpSp>
          <p:nvGrpSpPr>
            <p:cNvPr id="78" name="Group 77"/>
            <p:cNvGrpSpPr/>
            <p:nvPr/>
          </p:nvGrpSpPr>
          <p:grpSpPr>
            <a:xfrm>
              <a:off x="9645314" y="2897416"/>
              <a:ext cx="1615749" cy="972424"/>
              <a:chOff x="8966384" y="4621063"/>
              <a:chExt cx="1886955" cy="1369985"/>
            </a:xfrm>
          </p:grpSpPr>
          <p:sp>
            <p:nvSpPr>
              <p:cNvPr id="100" name="Rounded Rectangle 99"/>
              <p:cNvSpPr/>
              <p:nvPr/>
            </p:nvSpPr>
            <p:spPr>
              <a:xfrm>
                <a:off x="8966384" y="4621063"/>
                <a:ext cx="1616060" cy="1359484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101" name="Rectangle 100"/>
              <p:cNvSpPr/>
              <p:nvPr/>
            </p:nvSpPr>
            <p:spPr>
              <a:xfrm>
                <a:off x="8966384" y="4646869"/>
                <a:ext cx="1886955" cy="134417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Hepatic Fibrosis/Hepatic Stellate Cell Activation</a:t>
                </a:r>
                <a:endParaRPr lang="en-US" sz="1400" b="1" dirty="0"/>
              </a:p>
            </p:txBody>
          </p:sp>
        </p:grpSp>
        <p:cxnSp>
          <p:nvCxnSpPr>
            <p:cNvPr id="79" name="Straight Connector 78"/>
            <p:cNvCxnSpPr>
              <a:stCxn id="104" idx="2"/>
              <a:endCxn id="102" idx="0"/>
            </p:cNvCxnSpPr>
            <p:nvPr/>
          </p:nvCxnSpPr>
          <p:spPr>
            <a:xfrm flipH="1">
              <a:off x="8876741" y="1516769"/>
              <a:ext cx="1713278" cy="94540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Straight Connector 79"/>
            <p:cNvCxnSpPr>
              <a:stCxn id="98" idx="3"/>
              <a:endCxn id="101" idx="1"/>
            </p:cNvCxnSpPr>
            <p:nvPr/>
          </p:nvCxnSpPr>
          <p:spPr>
            <a:xfrm>
              <a:off x="7755208" y="3184290"/>
              <a:ext cx="1890106" cy="208497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>
              <a:stCxn id="104" idx="2"/>
              <a:endCxn id="100" idx="0"/>
            </p:cNvCxnSpPr>
            <p:nvPr/>
          </p:nvCxnSpPr>
          <p:spPr>
            <a:xfrm flipH="1">
              <a:off x="10337209" y="1516769"/>
              <a:ext cx="252810" cy="1380647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Straight Connector 81"/>
            <p:cNvCxnSpPr>
              <a:stCxn id="106" idx="3"/>
              <a:endCxn id="104" idx="1"/>
            </p:cNvCxnSpPr>
            <p:nvPr/>
          </p:nvCxnSpPr>
          <p:spPr>
            <a:xfrm>
              <a:off x="8225602" y="1159429"/>
              <a:ext cx="1449021" cy="97022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Straight Connector 82"/>
            <p:cNvCxnSpPr>
              <a:stCxn id="106" idx="2"/>
              <a:endCxn id="99" idx="0"/>
            </p:cNvCxnSpPr>
            <p:nvPr/>
          </p:nvCxnSpPr>
          <p:spPr>
            <a:xfrm flipH="1">
              <a:off x="7193249" y="1406514"/>
              <a:ext cx="470661" cy="1525325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4" name="Straight Connector 83"/>
            <p:cNvCxnSpPr>
              <a:stCxn id="102" idx="3"/>
              <a:endCxn id="100" idx="0"/>
            </p:cNvCxnSpPr>
            <p:nvPr/>
          </p:nvCxnSpPr>
          <p:spPr>
            <a:xfrm>
              <a:off x="9438433" y="2709262"/>
              <a:ext cx="898776" cy="188154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>
              <a:stCxn id="99" idx="0"/>
              <a:endCxn id="104" idx="2"/>
            </p:cNvCxnSpPr>
            <p:nvPr/>
          </p:nvCxnSpPr>
          <p:spPr>
            <a:xfrm flipV="1">
              <a:off x="7193249" y="1516769"/>
              <a:ext cx="3396770" cy="141507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85"/>
            <p:cNvSpPr txBox="1"/>
            <p:nvPr/>
          </p:nvSpPr>
          <p:spPr>
            <a:xfrm>
              <a:off x="7123203" y="2024113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5</a:t>
              </a:r>
              <a:endParaRPr lang="en-US" sz="1200" b="1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8206020" y="176268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5</a:t>
              </a:r>
              <a:endParaRPr lang="en-US" sz="1200" b="1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8822377" y="991014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13</a:t>
              </a:r>
              <a:endParaRPr lang="en-US" sz="1200" b="1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8713540" y="3085424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5</a:t>
              </a:r>
              <a:endParaRPr lang="en-US" sz="1200" b="1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10406276" y="2175179"/>
              <a:ext cx="401677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b="1" dirty="0" smtClean="0"/>
                <a:t>16</a:t>
              </a:r>
              <a:endParaRPr lang="en-US" sz="1200" b="1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9618488" y="2570762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/>
                <a:t>8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7905313" y="2889062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63</a:t>
              </a:r>
              <a:endParaRPr lang="en-US" sz="1200" b="1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9654582" y="190492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38</a:t>
              </a:r>
              <a:endParaRPr lang="en-US" sz="1200" b="1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8805874" y="1968496"/>
              <a:ext cx="34176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smtClean="0"/>
                <a:t>35</a:t>
              </a:r>
              <a:endParaRPr lang="en-US" sz="1200" b="1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6631910" y="433027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C</a:t>
              </a:r>
            </a:p>
          </p:txBody>
        </p:sp>
        <p:grpSp>
          <p:nvGrpSpPr>
            <p:cNvPr id="96" name="Group 95"/>
            <p:cNvGrpSpPr/>
            <p:nvPr/>
          </p:nvGrpSpPr>
          <p:grpSpPr>
            <a:xfrm>
              <a:off x="6580720" y="2913521"/>
              <a:ext cx="1225058" cy="541538"/>
              <a:chOff x="9361481" y="4621062"/>
              <a:chExt cx="1491858" cy="762937"/>
            </a:xfrm>
          </p:grpSpPr>
          <p:sp>
            <p:nvSpPr>
              <p:cNvPr id="98" name="Rounded Rectangle 97"/>
              <p:cNvSpPr/>
              <p:nvPr/>
            </p:nvSpPr>
            <p:spPr>
              <a:xfrm>
                <a:off x="9361481" y="4621062"/>
                <a:ext cx="1430274" cy="762936"/>
              </a:xfrm>
              <a:prstGeom prst="roundRect">
                <a:avLst/>
              </a:prstGeom>
              <a:noFill/>
              <a:ln w="222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/>
              </a:p>
            </p:txBody>
          </p:sp>
          <p:sp>
            <p:nvSpPr>
              <p:cNvPr id="99" name="Rectangle 98"/>
              <p:cNvSpPr/>
              <p:nvPr/>
            </p:nvSpPr>
            <p:spPr>
              <a:xfrm>
                <a:off x="9361481" y="4646869"/>
                <a:ext cx="1491858" cy="73713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1400" b="1" dirty="0" smtClean="0"/>
                  <a:t>Dendritic cell maturation</a:t>
                </a:r>
                <a:endParaRPr lang="en-US" sz="1400" b="1" dirty="0"/>
              </a:p>
            </p:txBody>
          </p:sp>
        </p:grpSp>
        <p:cxnSp>
          <p:nvCxnSpPr>
            <p:cNvPr id="97" name="Straight Connector 96"/>
            <p:cNvCxnSpPr>
              <a:stCxn id="98" idx="3"/>
              <a:endCxn id="102" idx="2"/>
            </p:cNvCxnSpPr>
            <p:nvPr/>
          </p:nvCxnSpPr>
          <p:spPr>
            <a:xfrm flipV="1">
              <a:off x="7755208" y="2956347"/>
              <a:ext cx="1121533" cy="22794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602750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957</TotalTime>
  <Words>94</Words>
  <Application>Microsoft Office PowerPoint</Application>
  <PresentationFormat>Custom</PresentationFormat>
  <Paragraphs>48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orella Rossi</dc:creator>
  <cp:lastModifiedBy>RTORRES</cp:lastModifiedBy>
  <cp:revision>242</cp:revision>
  <cp:lastPrinted>2019-01-20T19:05:41Z</cp:lastPrinted>
  <dcterms:created xsi:type="dcterms:W3CDTF">2019-01-09T21:33:31Z</dcterms:created>
  <dcterms:modified xsi:type="dcterms:W3CDTF">2019-11-30T00:52:04Z</dcterms:modified>
</cp:coreProperties>
</file>